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64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635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621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775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781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544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924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736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06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152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787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954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CA118-B1FB-43B1-A3FE-979B5A04EA39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914623-D49A-44E1-9949-FF459C94E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561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image3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5228" y="504333"/>
            <a:ext cx="9087439" cy="51792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782424" y="5907036"/>
            <a:ext cx="10275217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Supplementary Figure 1.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Correlatio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plots representing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pattern of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expression in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transcriptom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A, B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) and small RNA (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C, D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)  sequencing datasets between two independent biological replicates of control and day 2 stage of coleoptile senescence in rice. 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0682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image1.jpg" descr="supplementary2-0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3742" y="286372"/>
            <a:ext cx="5150444" cy="5965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6731" y="6251497"/>
            <a:ext cx="11779895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Supplementary Figure 2. Differentially expressed genes (DEGs) belonging to different categories. (A) </a:t>
            </a:r>
            <a:r>
              <a:rPr kumimoji="0" lang="en-US" altLang="en-US" sz="11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signalling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(B) redox and plant hormones (C-K).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Heatmaps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showing the expression profile of differentially expressed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auxi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C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ethylene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D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ABA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E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JA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F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GA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G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SA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H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BR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I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,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cytokini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J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metabolism genes in rice coleoptile senescence. 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(K)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major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upregulated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hormone pathway genes.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454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3073" name="image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2076" y="155341"/>
            <a:ext cx="4365625" cy="65833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5822856" y="5425975"/>
            <a:ext cx="5894661" cy="938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Supplementary Figure 3. Gene ontology (GO) analysis of predicted targets of </a:t>
            </a:r>
            <a:r>
              <a:rPr kumimoji="0" lang="en-US" altLang="en-US" sz="11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miRNAs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 (both conserved and novel) identified in rice coleoptile senescence dataset.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 Unicode MS" panose="020B0604020202020204" pitchFamily="34" charset="-128"/>
              </a:rPr>
              <a:t>Top 10 sub-categories were selected for each category and are represented here. MF: molecular function, CC: cellular component, BP: biological process, DEGs: differentially expressed genes.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4492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90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 Unicode M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yothish</dc:creator>
  <cp:lastModifiedBy>Jyothish</cp:lastModifiedBy>
  <cp:revision>2</cp:revision>
  <dcterms:created xsi:type="dcterms:W3CDTF">2022-09-20T18:16:42Z</dcterms:created>
  <dcterms:modified xsi:type="dcterms:W3CDTF">2022-09-20T18:21:18Z</dcterms:modified>
</cp:coreProperties>
</file>